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F80B3B7-7FB6-01F3-344F-7A57EDBD5485}" name="Lisa Caproni" initials="LC" userId="S::lisa.caproni@touchlight.com::0d1d998c-7f68-4d67-b9ca-fe943eb1b810" providerId="AD"/>
  <p188:author id="{E54CEBC3-B931-D387-F1E2-F08E2265DB98}" name="Tregoning, John S" initials="TS" userId="S::jst99@ic.ac.uk::7d65dd8a-a4ae-4f52-962a-1ae066ff34fe" providerId="AD"/>
  <p188:author id="{843C06D3-BABC-A8F8-6ABE-D337C380988D}" name="Helen Horton" initials="HH" userId="S::helen.horton@touchlight.com::f1412100-a593-42d1-80c0-985d97c7d60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32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8/10/relationships/authors" Target="author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regoning, John S" userId="7d65dd8a-a4ae-4f52-962a-1ae066ff34fe" providerId="ADAL" clId="{BE29B52D-AC57-4CDD-90BF-5DC7460C53CE}"/>
    <pc:docChg chg="delSld">
      <pc:chgData name="Tregoning, John S" userId="7d65dd8a-a4ae-4f52-962a-1ae066ff34fe" providerId="ADAL" clId="{BE29B52D-AC57-4CDD-90BF-5DC7460C53CE}" dt="2023-11-08T16:19:37.460" v="0" actId="47"/>
      <pc:docMkLst>
        <pc:docMk/>
      </pc:docMkLst>
      <pc:sldChg chg="del">
        <pc:chgData name="Tregoning, John S" userId="7d65dd8a-a4ae-4f52-962a-1ae066ff34fe" providerId="ADAL" clId="{BE29B52D-AC57-4CDD-90BF-5DC7460C53CE}" dt="2023-11-08T16:19:37.460" v="0" actId="47"/>
        <pc:sldMkLst>
          <pc:docMk/>
          <pc:sldMk cId="2367500259" sldId="256"/>
        </pc:sldMkLst>
      </pc:sldChg>
      <pc:sldChg chg="del">
        <pc:chgData name="Tregoning, John S" userId="7d65dd8a-a4ae-4f52-962a-1ae066ff34fe" providerId="ADAL" clId="{BE29B52D-AC57-4CDD-90BF-5DC7460C53CE}" dt="2023-11-08T16:19:37.460" v="0" actId="47"/>
        <pc:sldMkLst>
          <pc:docMk/>
          <pc:sldMk cId="2087455770" sldId="257"/>
        </pc:sldMkLst>
      </pc:sldChg>
      <pc:sldChg chg="del">
        <pc:chgData name="Tregoning, John S" userId="7d65dd8a-a4ae-4f52-962a-1ae066ff34fe" providerId="ADAL" clId="{BE29B52D-AC57-4CDD-90BF-5DC7460C53CE}" dt="2023-11-08T16:19:37.460" v="0" actId="47"/>
        <pc:sldMkLst>
          <pc:docMk/>
          <pc:sldMk cId="929202552" sldId="258"/>
        </pc:sldMkLst>
      </pc:sldChg>
      <pc:sldChg chg="del">
        <pc:chgData name="Tregoning, John S" userId="7d65dd8a-a4ae-4f52-962a-1ae066ff34fe" providerId="ADAL" clId="{BE29B52D-AC57-4CDD-90BF-5DC7460C53CE}" dt="2023-11-08T16:19:37.460" v="0" actId="47"/>
        <pc:sldMkLst>
          <pc:docMk/>
          <pc:sldMk cId="1436324914" sldId="261"/>
        </pc:sldMkLst>
      </pc:sldChg>
      <pc:sldChg chg="del">
        <pc:chgData name="Tregoning, John S" userId="7d65dd8a-a4ae-4f52-962a-1ae066ff34fe" providerId="ADAL" clId="{BE29B52D-AC57-4CDD-90BF-5DC7460C53CE}" dt="2023-11-08T16:19:37.460" v="0" actId="47"/>
        <pc:sldMkLst>
          <pc:docMk/>
          <pc:sldMk cId="1796364639" sldId="26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656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945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4670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7217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082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68683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5886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09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00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7785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524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E1C0C8-2CA7-4ACC-B308-FD45E88ABE9B}" type="datetimeFigureOut">
              <a:rPr lang="en-GB" smtClean="0"/>
              <a:t>08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5990C1-F82D-4DE3-973C-DFB46B808C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24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diagram of a diagram of a number of objects&#10;&#10;Description automatically generated">
            <a:extLst>
              <a:ext uri="{FF2B5EF4-FFF2-40B4-BE49-F238E27FC236}">
                <a16:creationId xmlns:a16="http://schemas.microsoft.com/office/drawing/2014/main" id="{94EAAC32-5996-BF5B-7D03-81616BBB74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5632" y="2998785"/>
            <a:ext cx="5309937" cy="2438951"/>
          </a:xfrm>
          <a:prstGeom prst="rect">
            <a:avLst/>
          </a:prstGeom>
        </p:spPr>
      </p:pic>
      <p:sp>
        <p:nvSpPr>
          <p:cNvPr id="4" name="Rectangle 2">
            <a:extLst>
              <a:ext uri="{FF2B5EF4-FFF2-40B4-BE49-F238E27FC236}">
                <a16:creationId xmlns:a16="http://schemas.microsoft.com/office/drawing/2014/main" id="{60280522-FE52-63DF-FE2D-513CEAB549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5632" y="2828544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6" name="Rectangle 4">
            <a:extLst>
              <a:ext uri="{FF2B5EF4-FFF2-40B4-BE49-F238E27FC236}">
                <a16:creationId xmlns:a16="http://schemas.microsoft.com/office/drawing/2014/main" id="{C11762AD-7692-83BD-3DD2-651812E8DF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3968" y="2633472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0995F35-36BF-C7E2-7C4E-63BAC29E6F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8061243"/>
              </p:ext>
            </p:extLst>
          </p:nvPr>
        </p:nvGraphicFramePr>
        <p:xfrm>
          <a:off x="789154" y="5124957"/>
          <a:ext cx="5189537" cy="3036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413920" imgH="3147026" progId="Prism10.Document">
                  <p:embed/>
                </p:oleObj>
              </mc:Choice>
              <mc:Fallback>
                <p:oleObj name="Prism 10" r:id="rId3" imgW="5413920" imgH="3147026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0995F35-36BF-C7E2-7C4E-63BAC29E6F1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89154" y="5124957"/>
                        <a:ext cx="5189537" cy="30368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13F7CD1D-05B0-07D9-18AD-BA73D9F18710}"/>
              </a:ext>
            </a:extLst>
          </p:cNvPr>
          <p:cNvSpPr txBox="1"/>
          <p:nvPr/>
        </p:nvSpPr>
        <p:spPr>
          <a:xfrm>
            <a:off x="0" y="8151674"/>
            <a:ext cx="6858001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Figure S1. </a:t>
            </a:r>
            <a:r>
              <a:rPr lang="en-GB" sz="1600" b="1" dirty="0">
                <a:effectLst/>
                <a:ea typeface="Times New Roman" panose="02020603050405020304" pitchFamily="18" charset="0"/>
              </a:rPr>
              <a:t>Flow cytometry to confirm cell depletion. </a:t>
            </a:r>
            <a:r>
              <a:rPr lang="en-GB" sz="1600" dirty="0"/>
              <a:t>Flow cytometry </a:t>
            </a:r>
            <a:r>
              <a:rPr lang="en-GB" sz="1600" dirty="0">
                <a:solidFill>
                  <a:srgbClr val="000000"/>
                </a:solidFill>
                <a:effectLst/>
                <a:ea typeface="Calibri" panose="020F0502020204030204" pitchFamily="34" charset="0"/>
              </a:rPr>
              <a:t>Gating Strategy for A) NK cell depletion study B) CD8 depletion study. Representative conventional flow cytometry plots from mouse lymphocytes (isolated from lung tissue) showing the hierarchical phenotype staining. 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C) NK cells following Anti-asialo GM1 treatment; D) CD8 T </a:t>
            </a:r>
            <a:r>
              <a:rPr lang="en-GB" sz="1600" dirty="0">
                <a:ea typeface="Times New Roman" panose="02020603050405020304" pitchFamily="18" charset="0"/>
              </a:rPr>
              <a:t>following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 </a:t>
            </a:r>
            <a:r>
              <a:rPr lang="en-GB" sz="1600" dirty="0">
                <a:ea typeface="Times New Roman" panose="02020603050405020304" pitchFamily="18" charset="0"/>
              </a:rPr>
              <a:t>anti-CD8 </a:t>
            </a:r>
            <a:r>
              <a:rPr lang="en-GB" sz="1600" dirty="0">
                <a:effectLst/>
                <a:ea typeface="Times New Roman" panose="02020603050405020304" pitchFamily="18" charset="0"/>
              </a:rPr>
              <a:t>treatment specific antibody treatment. </a:t>
            </a:r>
            <a:endParaRPr lang="en-GB" sz="1600" dirty="0"/>
          </a:p>
        </p:txBody>
      </p:sp>
      <p:pic>
        <p:nvPicPr>
          <p:cNvPr id="2" name="Picture 1" descr="A diagram of a graph&#10;&#10;Description automatically generated">
            <a:extLst>
              <a:ext uri="{FF2B5EF4-FFF2-40B4-BE49-F238E27FC236}">
                <a16:creationId xmlns:a16="http://schemas.microsoft.com/office/drawing/2014/main" id="{FC196176-B21D-82CC-7546-A91532A7DF9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2135" y="186695"/>
            <a:ext cx="4296556" cy="261424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17C1D42-38D0-618D-0720-923C01FCA719}"/>
              </a:ext>
            </a:extLst>
          </p:cNvPr>
          <p:cNvSpPr txBox="1"/>
          <p:nvPr/>
        </p:nvSpPr>
        <p:spPr>
          <a:xfrm>
            <a:off x="624562" y="164134"/>
            <a:ext cx="329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7B9588A-5736-DD25-4D87-0EA266059B39}"/>
              </a:ext>
            </a:extLst>
          </p:cNvPr>
          <p:cNvSpPr txBox="1"/>
          <p:nvPr/>
        </p:nvSpPr>
        <p:spPr>
          <a:xfrm>
            <a:off x="701040" y="2800935"/>
            <a:ext cx="329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73829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4E9E0B16CC0B549A6A43A8DA4C75AB3" ma:contentTypeVersion="17" ma:contentTypeDescription="Create a new document." ma:contentTypeScope="" ma:versionID="a76ae86ffff4630a6b2f8c29ae8774b4">
  <xsd:schema xmlns:xsd="http://www.w3.org/2001/XMLSchema" xmlns:xs="http://www.w3.org/2001/XMLSchema" xmlns:p="http://schemas.microsoft.com/office/2006/metadata/properties" xmlns:ns2="4c4cfd5a-32ec-4173-886b-8e290cc6091e" xmlns:ns3="a7de16ec-9614-4849-87ee-6ce9d25bb968" targetNamespace="http://schemas.microsoft.com/office/2006/metadata/properties" ma:root="true" ma:fieldsID="f5aec528245e28d8b39cb38e2ba76c7b" ns2:_="" ns3:_="">
    <xsd:import namespace="4c4cfd5a-32ec-4173-886b-8e290cc6091e"/>
    <xsd:import namespace="a7de16ec-9614-4849-87ee-6ce9d25bb96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LengthInSecond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Location" minOccurs="0"/>
                <xsd:element ref="ns2:lcf76f155ced4ddcb4097134ff3c332f" minOccurs="0"/>
                <xsd:element ref="ns3:TaxCatchAll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4cfd5a-32ec-4173-886b-8e290cc609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e7343cbc-184a-4947-90ca-9efcefd38f2f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de16ec-9614-4849-87ee-6ce9d25bb968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6b21bee8-57cf-478e-851b-88ee1454c12e}" ma:internalName="TaxCatchAll" ma:showField="CatchAllData" ma:web="a7de16ec-9614-4849-87ee-6ce9d25bb96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4c4cfd5a-32ec-4173-886b-8e290cc6091e">
      <Terms xmlns="http://schemas.microsoft.com/office/infopath/2007/PartnerControls"/>
    </lcf76f155ced4ddcb4097134ff3c332f>
    <TaxCatchAll xmlns="a7de16ec-9614-4849-87ee-6ce9d25bb968" xsi:nil="true"/>
  </documentManagement>
</p:properties>
</file>

<file path=customXml/itemProps1.xml><?xml version="1.0" encoding="utf-8"?>
<ds:datastoreItem xmlns:ds="http://schemas.openxmlformats.org/officeDocument/2006/customXml" ds:itemID="{2E9BB8C5-1A20-4E9D-8C01-45D0003C44C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60FF483-9BFD-409E-B556-74880DC6055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4cfd5a-32ec-4173-886b-8e290cc6091e"/>
    <ds:schemaRef ds:uri="a7de16ec-9614-4849-87ee-6ce9d25bb96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B9F0490-C1A1-4393-9CB2-0A8B5D89FCC4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a7de16ec-9614-4849-87ee-6ce9d25bb968"/>
    <ds:schemaRef ds:uri="http://purl.org/dc/terms/"/>
    <ds:schemaRef ds:uri="http://purl.org/dc/dcmitype/"/>
    <ds:schemaRef ds:uri="http://schemas.openxmlformats.org/package/2006/metadata/core-properties"/>
    <ds:schemaRef ds:uri="4c4cfd5a-32ec-4173-886b-8e290cc6091e"/>
    <ds:schemaRef ds:uri="http://www.w3.org/XML/1998/namespace"/>
  </ds:schemaRefs>
</ds:datastoreItem>
</file>

<file path=docMetadata/LabelInfo.xml><?xml version="1.0" encoding="utf-8"?>
<clbl:labelList xmlns:clbl="http://schemas.microsoft.com/office/2020/mipLabelMetadata">
  <clbl:label id="{3f72d7f0-e6b7-4638-90b6-2c94223cc08b}" enabled="0" method="" siteId="{3f72d7f0-e6b7-4638-90b6-2c94223cc08b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</TotalTime>
  <Words>69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nliffe, Robert F</dc:creator>
  <cp:lastModifiedBy>Tregoning, John S</cp:lastModifiedBy>
  <cp:revision>2</cp:revision>
  <dcterms:created xsi:type="dcterms:W3CDTF">2023-06-13T14:03:23Z</dcterms:created>
  <dcterms:modified xsi:type="dcterms:W3CDTF">2023-11-08T16:19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DF0D785AA07084B89C73B780727CF12</vt:lpwstr>
  </property>
  <property fmtid="{D5CDD505-2E9C-101B-9397-08002B2CF9AE}" pid="3" name="MediaServiceImageTags">
    <vt:lpwstr/>
  </property>
</Properties>
</file>